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1" r:id="rId6"/>
    <p:sldId id="262" r:id="rId7"/>
    <p:sldId id="265" r:id="rId8"/>
    <p:sldId id="266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80" d="100"/>
          <a:sy n="80" d="100"/>
        </p:scale>
        <p:origin x="576" y="3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C563E8-5887-4053-B3F1-3B483A5FFF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0E3A28E-A840-471F-AF4F-4BAD5B72F3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921208-4A2F-4809-9AF7-862673818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965130-E9C3-4219-BA3B-5DF398064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8560BF-4014-40A0-8701-8D66803E9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2345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A5DFBB-2F9D-4A5C-8151-6400A083CD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B351CB-875B-45FB-999B-A245EA5960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4401A8-B571-47AB-A02E-D219C18085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0047BE-65DC-44A7-A264-8E80418E8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9F8D90-FB8D-4D6E-B178-55237A1CB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6973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811106-DC10-42FC-97DF-89197176E3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8D5529-FC11-4509-B6F8-C80446F7D4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587EBA-CFE5-4C82-A9DE-D0D5D403D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0C0147-40DA-432E-AE26-8380102BB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EF2112-6778-4A5E-9602-4D56EDE7E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0799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7165A-51E4-4925-A9A8-E552E283D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3CD8AD-76BD-4783-9F82-8AAA2C36E5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1003CC-8B4B-4EC6-A623-C689B5C3E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46BCE7-70FB-4BA8-9B4E-F7C16EBFB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87C4D5-F56F-47B0-8588-716565CF4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62139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DF2D9-A9DF-493B-A70F-85CD2687BF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CD2D1D-684B-406E-A056-1011C03287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38465-D05C-40D8-B459-0A42FFE07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E868D1-40A4-4784-9C30-C92F2781B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E27F0D-9D31-4B80-925D-212791A1AE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1842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AFEB8-FAE6-4563-92BE-49AF6F57BC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D1C3A2-B214-4CD3-9735-733BE81954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AC179C-FD7E-45F4-AE50-B9AD43937C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13AF69-8905-4333-953A-4EA658A1F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8EAFA2-E1D3-4E18-AE5A-DD7EC1296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A45016-1721-4CDC-A768-D3EF9A60F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0774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A53C8-59C7-4253-B68F-F448CED8B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9BBFB3-BE50-40CC-9C2F-68FD6CA8A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9718F9-968E-4D42-B39C-B9A125A10E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290054-D15B-41E0-8906-AFFF8C9E08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8E4DAF-06A6-4DBE-B93C-DA288BCD7F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D01880C-7D7E-4A58-BB5F-166E92C1E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AC0D02-80D4-4C2F-934C-3D8FD386C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FE48A7A-3EF3-43A1-9CEC-7AF9709BE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20418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6D8C90-D928-4E7F-ADC9-1AD3932BD9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A4ED3CD-78A9-47FD-B8DD-D5BEDD1D1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DA5865-6A91-46A6-8C29-2ED613643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6CA2E9F-4474-4126-81CB-98BF004B0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3971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68DE618-B09D-4132-8F71-6656AA31E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A81554-823F-4BB6-9972-E7AE5FF48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CD71949-A7C6-4399-838A-260D2510C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02147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93A79-7B43-42D2-844F-9E919FDC5B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1F59F2-5ADB-44B9-82AF-E35836D526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37BC5B-038B-43F2-97D4-8D44DFFFC4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EE5653-3418-4F49-BAB6-FF21DFB01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8181D4-E8E8-44D3-9E69-BDA6701A4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D392EF-C666-46C9-B15D-142E22008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60718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1F7DF0-1CCB-4E8B-B8CC-B357AF2196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6956EB2-4BC3-4E13-852A-6E73170779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DF199C-B125-4800-8BA9-330941DAF3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A2E992-18B4-431B-869F-D39EE4002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D071A6-E400-4D48-A39D-C19E73CCE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C8F994-6EF9-4EF0-BD70-BA7ED3E55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83508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C96568B-8EDD-49D6-8986-86244351A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D9AFB4-47FA-4EAF-B1B9-DA8CD4FB89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DCC352-AADB-42D8-A781-8CF2B7493B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A9BE1-919A-47B8-9693-7CF78089FD15}" type="datetimeFigureOut">
              <a:rPr lang="en-CA" smtClean="0"/>
              <a:t>2022-01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6D3F33-21FC-4821-BEBC-4E28F1ADDB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D3128D-2994-4093-934E-998D6495B3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C2A2FA-78E5-40B8-895A-406C539DD0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49562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w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em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EA2A476-E89C-4F0E-A288-894D0A282DC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8675" y="536897"/>
            <a:ext cx="7734649" cy="5578678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51D0265-B184-49AB-9917-FC08CCF28473}"/>
              </a:ext>
            </a:extLst>
          </p:cNvPr>
          <p:cNvSpPr txBox="1"/>
          <p:nvPr/>
        </p:nvSpPr>
        <p:spPr>
          <a:xfrm>
            <a:off x="7354570" y="6153698"/>
            <a:ext cx="118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</a:t>
            </a:r>
            <a:endParaRPr lang="en-CA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0BF7909-9B73-4100-96FD-CECAEB8C5CDD}"/>
              </a:ext>
            </a:extLst>
          </p:cNvPr>
          <p:cNvSpPr txBox="1"/>
          <p:nvPr/>
        </p:nvSpPr>
        <p:spPr>
          <a:xfrm>
            <a:off x="2634145" y="494951"/>
            <a:ext cx="197141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FC_Male</a:t>
            </a:r>
            <a:endParaRPr lang="en-CA" sz="16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5FF49B1-CD84-4A90-89E1-1CF33BEC7255}"/>
              </a:ext>
            </a:extLst>
          </p:cNvPr>
          <p:cNvSpPr txBox="1"/>
          <p:nvPr/>
        </p:nvSpPr>
        <p:spPr>
          <a:xfrm>
            <a:off x="5253014" y="503556"/>
            <a:ext cx="211252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HIP_Male</a:t>
            </a:r>
            <a:endParaRPr lang="en-CA" sz="16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89635A-DD78-4FE8-B25D-B56918A9FAC4}"/>
              </a:ext>
            </a:extLst>
          </p:cNvPr>
          <p:cNvSpPr txBox="1"/>
          <p:nvPr/>
        </p:nvSpPr>
        <p:spPr>
          <a:xfrm>
            <a:off x="7863388" y="503448"/>
            <a:ext cx="211252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CER_Male</a:t>
            </a:r>
            <a:endParaRPr lang="en-CA" sz="16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128F4E4-FA2F-4C1D-81A9-2452DEB19807}"/>
              </a:ext>
            </a:extLst>
          </p:cNvPr>
          <p:cNvSpPr txBox="1"/>
          <p:nvPr/>
        </p:nvSpPr>
        <p:spPr>
          <a:xfrm>
            <a:off x="2769765" y="3364695"/>
            <a:ext cx="213919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FC_Female</a:t>
            </a:r>
            <a:endParaRPr lang="en-CA" sz="16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209D366-700F-4B09-B8D3-CD69F06B1377}"/>
              </a:ext>
            </a:extLst>
          </p:cNvPr>
          <p:cNvSpPr txBox="1"/>
          <p:nvPr/>
        </p:nvSpPr>
        <p:spPr>
          <a:xfrm>
            <a:off x="5275957" y="3373300"/>
            <a:ext cx="229230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HIP_Female</a:t>
            </a:r>
            <a:endParaRPr lang="en-CA" sz="16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608F949-C4CC-4161-AAF1-180416DD774C}"/>
              </a:ext>
            </a:extLst>
          </p:cNvPr>
          <p:cNvSpPr txBox="1"/>
          <p:nvPr/>
        </p:nvSpPr>
        <p:spPr>
          <a:xfrm>
            <a:off x="7844386" y="3373192"/>
            <a:ext cx="229230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CER_Female</a:t>
            </a:r>
            <a:endParaRPr lang="en-CA" sz="1600" b="1" dirty="0"/>
          </a:p>
        </p:txBody>
      </p:sp>
    </p:spTree>
    <p:extLst>
      <p:ext uri="{BB962C8B-B14F-4D97-AF65-F5344CB8AC3E}">
        <p14:creationId xmlns:p14="http://schemas.microsoft.com/office/powerpoint/2010/main" val="22383442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51D0265-B184-49AB-9917-FC08CCF28473}"/>
              </a:ext>
            </a:extLst>
          </p:cNvPr>
          <p:cNvSpPr txBox="1"/>
          <p:nvPr/>
        </p:nvSpPr>
        <p:spPr>
          <a:xfrm>
            <a:off x="8315308" y="5898393"/>
            <a:ext cx="118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</a:t>
            </a:r>
            <a:endParaRPr lang="en-CA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E8E4C38-4E32-4883-8DEF-51E84BC52AD4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2535" y="1062891"/>
            <a:ext cx="7366930" cy="4961604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B3677E4-9C69-4727-8DC7-9C4AFD709880}"/>
              </a:ext>
            </a:extLst>
          </p:cNvPr>
          <p:cNvSpPr txBox="1"/>
          <p:nvPr/>
        </p:nvSpPr>
        <p:spPr>
          <a:xfrm>
            <a:off x="2835479" y="1065403"/>
            <a:ext cx="177007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FC_Male</a:t>
            </a:r>
            <a:endParaRPr lang="en-CA" sz="16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E1793C-4411-4742-AE23-612F6307D9DA}"/>
              </a:ext>
            </a:extLst>
          </p:cNvPr>
          <p:cNvSpPr txBox="1"/>
          <p:nvPr/>
        </p:nvSpPr>
        <p:spPr>
          <a:xfrm>
            <a:off x="5468758" y="1074008"/>
            <a:ext cx="189677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HIP_Male</a:t>
            </a:r>
            <a:endParaRPr lang="en-CA" sz="16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ECCA504-F52C-4CED-86B3-96BA23A7BE6F}"/>
              </a:ext>
            </a:extLst>
          </p:cNvPr>
          <p:cNvSpPr txBox="1"/>
          <p:nvPr/>
        </p:nvSpPr>
        <p:spPr>
          <a:xfrm>
            <a:off x="7793906" y="1073900"/>
            <a:ext cx="189677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CER_Male</a:t>
            </a:r>
            <a:endParaRPr lang="en-CA" sz="16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7611FD-B2EB-4DD6-BB9C-FC6CDC6F10BE}"/>
              </a:ext>
            </a:extLst>
          </p:cNvPr>
          <p:cNvSpPr txBox="1"/>
          <p:nvPr/>
        </p:nvSpPr>
        <p:spPr>
          <a:xfrm>
            <a:off x="3046602" y="3574420"/>
            <a:ext cx="154878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FC_Female</a:t>
            </a:r>
            <a:endParaRPr lang="en-CA" sz="16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02700AC-DAB5-4E3C-AA1B-521A55AF7217}"/>
              </a:ext>
            </a:extLst>
          </p:cNvPr>
          <p:cNvSpPr txBox="1"/>
          <p:nvPr/>
        </p:nvSpPr>
        <p:spPr>
          <a:xfrm>
            <a:off x="5552795" y="3583025"/>
            <a:ext cx="165964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HIP_Female</a:t>
            </a:r>
            <a:endParaRPr lang="en-CA" sz="16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D8CF67-782C-4AEA-8F55-0F0BEF77A770}"/>
              </a:ext>
            </a:extLst>
          </p:cNvPr>
          <p:cNvSpPr txBox="1"/>
          <p:nvPr/>
        </p:nvSpPr>
        <p:spPr>
          <a:xfrm>
            <a:off x="7861165" y="3582917"/>
            <a:ext cx="165964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/>
              <a:t>CER_Female</a:t>
            </a:r>
            <a:endParaRPr lang="en-CA" sz="1600" b="1" dirty="0"/>
          </a:p>
        </p:txBody>
      </p:sp>
    </p:spTree>
    <p:extLst>
      <p:ext uri="{BB962C8B-B14F-4D97-AF65-F5344CB8AC3E}">
        <p14:creationId xmlns:p14="http://schemas.microsoft.com/office/powerpoint/2010/main" val="4455991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51D0265-B184-49AB-9917-FC08CCF28473}"/>
              </a:ext>
            </a:extLst>
          </p:cNvPr>
          <p:cNvSpPr txBox="1"/>
          <p:nvPr/>
        </p:nvSpPr>
        <p:spPr>
          <a:xfrm>
            <a:off x="8314323" y="6291742"/>
            <a:ext cx="118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3</a:t>
            </a:r>
            <a:endParaRPr lang="en-CA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9A87691-0343-42FD-B492-322738EEC11A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0921" y="528507"/>
            <a:ext cx="6744749" cy="5578678"/>
          </a:xfrm>
          <a:prstGeom prst="rect">
            <a:avLst/>
          </a:prstGeom>
          <a:noFill/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1320337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51D0265-B184-49AB-9917-FC08CCF28473}"/>
              </a:ext>
            </a:extLst>
          </p:cNvPr>
          <p:cNvSpPr txBox="1"/>
          <p:nvPr/>
        </p:nvSpPr>
        <p:spPr>
          <a:xfrm>
            <a:off x="7879080" y="4450080"/>
            <a:ext cx="118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</a:t>
            </a:r>
            <a:endParaRPr lang="en-CA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E56AC12-3FB0-43A5-B167-2A41133AD16E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5693" y="1510018"/>
            <a:ext cx="7630486" cy="2555959"/>
          </a:xfrm>
          <a:prstGeom prst="rect">
            <a:avLst/>
          </a:prstGeom>
          <a:noFill/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176727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51D0265-B184-49AB-9917-FC08CCF28473}"/>
              </a:ext>
            </a:extLst>
          </p:cNvPr>
          <p:cNvSpPr txBox="1"/>
          <p:nvPr/>
        </p:nvSpPr>
        <p:spPr>
          <a:xfrm>
            <a:off x="7879080" y="5435600"/>
            <a:ext cx="118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5</a:t>
            </a:r>
            <a:endParaRPr lang="en-CA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1D5A1A8-49BF-4D2A-9BF9-E0624AD71A67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199" y="1053068"/>
            <a:ext cx="6741253" cy="4273312"/>
          </a:xfrm>
          <a:prstGeom prst="rect">
            <a:avLst/>
          </a:prstGeom>
          <a:noFill/>
          <a:ln>
            <a:noFill/>
          </a:ln>
          <a:effectLst/>
        </p:spPr>
      </p:pic>
    </p:spTree>
    <p:extLst>
      <p:ext uri="{BB962C8B-B14F-4D97-AF65-F5344CB8AC3E}">
        <p14:creationId xmlns:p14="http://schemas.microsoft.com/office/powerpoint/2010/main" val="34322958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51D0265-B184-49AB-9917-FC08CCF28473}"/>
              </a:ext>
            </a:extLst>
          </p:cNvPr>
          <p:cNvSpPr txBox="1"/>
          <p:nvPr/>
        </p:nvSpPr>
        <p:spPr>
          <a:xfrm>
            <a:off x="7879080" y="5989320"/>
            <a:ext cx="118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6</a:t>
            </a:r>
            <a:endParaRPr lang="en-CA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D52CB37-2C31-4B5E-9291-7408DB5B8C1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124200" y="421640"/>
            <a:ext cx="5943600" cy="5567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75404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agram&#10;&#10;Description automatically generated">
            <a:extLst>
              <a:ext uri="{FF2B5EF4-FFF2-40B4-BE49-F238E27FC236}">
                <a16:creationId xmlns:a16="http://schemas.microsoft.com/office/drawing/2014/main" id="{243857D1-2808-4AB3-B7D2-32AC6F7036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6188" y="24206"/>
            <a:ext cx="3315749" cy="3315749"/>
          </a:xfrm>
          <a:prstGeom prst="rect">
            <a:avLst/>
          </a:prstGeom>
        </p:spPr>
      </p:pic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E11515A5-5768-45ED-9796-CB66E9652D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6784" y="24206"/>
            <a:ext cx="3315749" cy="331574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2FBB507-6D62-49E0-9186-5F9C2A5D4251}"/>
              </a:ext>
            </a:extLst>
          </p:cNvPr>
          <p:cNvSpPr txBox="1"/>
          <p:nvPr/>
        </p:nvSpPr>
        <p:spPr>
          <a:xfrm>
            <a:off x="6627115" y="328307"/>
            <a:ext cx="10571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male</a:t>
            </a:r>
            <a:endParaRPr lang="en-CA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7CCE37-E88E-4BFE-85AB-01C561CE1979}"/>
              </a:ext>
            </a:extLst>
          </p:cNvPr>
          <p:cNvSpPr txBox="1"/>
          <p:nvPr/>
        </p:nvSpPr>
        <p:spPr>
          <a:xfrm>
            <a:off x="3650422" y="328307"/>
            <a:ext cx="738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Male</a:t>
            </a:r>
            <a:endParaRPr lang="en-CA" sz="14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BB47549-949A-482C-B6B0-1A1B43BC8D2C}"/>
              </a:ext>
            </a:extLst>
          </p:cNvPr>
          <p:cNvSpPr txBox="1"/>
          <p:nvPr/>
        </p:nvSpPr>
        <p:spPr>
          <a:xfrm>
            <a:off x="2608544" y="297529"/>
            <a:ext cx="1105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rRF</a:t>
            </a:r>
            <a:endParaRPr lang="en-CA" dirty="0"/>
          </a:p>
        </p:txBody>
      </p:sp>
      <p:pic>
        <p:nvPicPr>
          <p:cNvPr id="11" name="Picture 10" descr="Diagram, venn diagram&#10;&#10;Description automatically generated">
            <a:extLst>
              <a:ext uri="{FF2B5EF4-FFF2-40B4-BE49-F238E27FC236}">
                <a16:creationId xmlns:a16="http://schemas.microsoft.com/office/drawing/2014/main" id="{83D59037-AAEE-4E1A-9D08-63C10BE37D9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6188" y="2810481"/>
            <a:ext cx="3315749" cy="3315749"/>
          </a:xfrm>
          <a:prstGeom prst="rect">
            <a:avLst/>
          </a:prstGeom>
        </p:spPr>
      </p:pic>
      <p:pic>
        <p:nvPicPr>
          <p:cNvPr id="16" name="Picture 15" descr="Diagram&#10;&#10;Description automatically generated">
            <a:extLst>
              <a:ext uri="{FF2B5EF4-FFF2-40B4-BE49-F238E27FC236}">
                <a16:creationId xmlns:a16="http://schemas.microsoft.com/office/drawing/2014/main" id="{F513F029-6806-447F-9D97-5AD459FA6B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6784" y="2793703"/>
            <a:ext cx="3315749" cy="331574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7FBF72D-60AE-42E0-AC52-3F1D356DFE86}"/>
              </a:ext>
            </a:extLst>
          </p:cNvPr>
          <p:cNvSpPr txBox="1"/>
          <p:nvPr/>
        </p:nvSpPr>
        <p:spPr>
          <a:xfrm>
            <a:off x="4289824" y="3125072"/>
            <a:ext cx="738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C</a:t>
            </a:r>
            <a:endParaRPr lang="en-CA" sz="14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42466CC-1B4C-477B-A0B6-9BFCF65AB03B}"/>
              </a:ext>
            </a:extLst>
          </p:cNvPr>
          <p:cNvSpPr txBox="1"/>
          <p:nvPr/>
        </p:nvSpPr>
        <p:spPr>
          <a:xfrm>
            <a:off x="6719581" y="3127958"/>
            <a:ext cx="735814" cy="3048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IP</a:t>
            </a:r>
            <a:endParaRPr lang="en-CA" sz="14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69CB828-2F64-4D11-B33C-C373DB875DFD}"/>
              </a:ext>
            </a:extLst>
          </p:cNvPr>
          <p:cNvSpPr txBox="1"/>
          <p:nvPr/>
        </p:nvSpPr>
        <p:spPr>
          <a:xfrm>
            <a:off x="7544658" y="5740120"/>
            <a:ext cx="118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7</a:t>
            </a:r>
            <a:endParaRPr lang="en-CA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226B590-494A-44FD-A4D6-B5D022D35B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75204" y="377190"/>
            <a:ext cx="6641592" cy="6103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73686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person&#10;&#10;Description automatically generated">
            <a:extLst>
              <a:ext uri="{FF2B5EF4-FFF2-40B4-BE49-F238E27FC236}">
                <a16:creationId xmlns:a16="http://schemas.microsoft.com/office/drawing/2014/main" id="{EE70026A-428F-4558-9653-98741DA263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8848" y="6291"/>
            <a:ext cx="3297961" cy="3297961"/>
          </a:xfrm>
          <a:prstGeom prst="rect">
            <a:avLst/>
          </a:prstGeom>
        </p:spPr>
      </p:pic>
      <p:pic>
        <p:nvPicPr>
          <p:cNvPr id="7" name="Picture 6" descr="A close up of a person&#10;&#10;Description automatically generated">
            <a:extLst>
              <a:ext uri="{FF2B5EF4-FFF2-40B4-BE49-F238E27FC236}">
                <a16:creationId xmlns:a16="http://schemas.microsoft.com/office/drawing/2014/main" id="{FDC4A395-9B20-41AC-A670-E424FDDF5F1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5213" y="-10487"/>
            <a:ext cx="3297961" cy="329796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2FBB507-6D62-49E0-9186-5F9C2A5D4251}"/>
              </a:ext>
            </a:extLst>
          </p:cNvPr>
          <p:cNvSpPr txBox="1"/>
          <p:nvPr/>
        </p:nvSpPr>
        <p:spPr>
          <a:xfrm>
            <a:off x="6056663" y="293615"/>
            <a:ext cx="10571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emale</a:t>
            </a:r>
            <a:endParaRPr lang="en-CA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7CCE37-E88E-4BFE-85AB-01C561CE1979}"/>
              </a:ext>
            </a:extLst>
          </p:cNvPr>
          <p:cNvSpPr txBox="1"/>
          <p:nvPr/>
        </p:nvSpPr>
        <p:spPr>
          <a:xfrm>
            <a:off x="3650422" y="293615"/>
            <a:ext cx="738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Male</a:t>
            </a:r>
            <a:endParaRPr lang="en-CA" sz="14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BB47549-949A-482C-B6B0-1A1B43BC8D2C}"/>
              </a:ext>
            </a:extLst>
          </p:cNvPr>
          <p:cNvSpPr txBox="1"/>
          <p:nvPr/>
        </p:nvSpPr>
        <p:spPr>
          <a:xfrm>
            <a:off x="2266991" y="469450"/>
            <a:ext cx="1105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nRF</a:t>
            </a:r>
            <a:endParaRPr lang="en-CA" dirty="0"/>
          </a:p>
        </p:txBody>
      </p:sp>
      <p:pic>
        <p:nvPicPr>
          <p:cNvPr id="11" name="Picture 10" descr="A person posing for the camera&#10;&#10;Description automatically generated">
            <a:extLst>
              <a:ext uri="{FF2B5EF4-FFF2-40B4-BE49-F238E27FC236}">
                <a16:creationId xmlns:a16="http://schemas.microsoft.com/office/drawing/2014/main" id="{7C637535-3B37-4BEB-A714-86E1E78FEEE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9888" y="2623991"/>
            <a:ext cx="3297961" cy="3297961"/>
          </a:xfrm>
          <a:prstGeom prst="rect">
            <a:avLst/>
          </a:prstGeom>
        </p:spPr>
      </p:pic>
      <p:pic>
        <p:nvPicPr>
          <p:cNvPr id="16" name="Picture 15" descr="Diagram, venn diagram&#10;&#10;Description automatically generated">
            <a:extLst>
              <a:ext uri="{FF2B5EF4-FFF2-40B4-BE49-F238E27FC236}">
                <a16:creationId xmlns:a16="http://schemas.microsoft.com/office/drawing/2014/main" id="{6E1C08FB-38B8-466F-BBD6-52812E1F2BA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350" y="2640769"/>
            <a:ext cx="3297961" cy="3297961"/>
          </a:xfrm>
          <a:prstGeom prst="rect">
            <a:avLst/>
          </a:prstGeom>
        </p:spPr>
      </p:pic>
      <p:pic>
        <p:nvPicPr>
          <p:cNvPr id="20" name="Picture 19" descr="A person posing for the camera&#10;&#10;Description automatically generated">
            <a:extLst>
              <a:ext uri="{FF2B5EF4-FFF2-40B4-BE49-F238E27FC236}">
                <a16:creationId xmlns:a16="http://schemas.microsoft.com/office/drawing/2014/main" id="{2AED89AF-B743-4B74-987C-74882A733A9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7645" y="2640769"/>
            <a:ext cx="3297961" cy="329796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12D9F81-5250-44A8-A217-8E54773EC81F}"/>
              </a:ext>
            </a:extLst>
          </p:cNvPr>
          <p:cNvSpPr txBox="1"/>
          <p:nvPr/>
        </p:nvSpPr>
        <p:spPr>
          <a:xfrm>
            <a:off x="2624667" y="3087150"/>
            <a:ext cx="747707" cy="3132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ER</a:t>
            </a:r>
            <a:endParaRPr lang="en-CA" sz="14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7FBF72D-60AE-42E0-AC52-3F1D356DFE86}"/>
              </a:ext>
            </a:extLst>
          </p:cNvPr>
          <p:cNvSpPr txBox="1"/>
          <p:nvPr/>
        </p:nvSpPr>
        <p:spPr>
          <a:xfrm>
            <a:off x="4885443" y="3092652"/>
            <a:ext cx="738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C</a:t>
            </a:r>
            <a:endParaRPr lang="en-CA" sz="14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42466CC-1B4C-477B-A0B6-9BFCF65AB03B}"/>
              </a:ext>
            </a:extLst>
          </p:cNvPr>
          <p:cNvSpPr txBox="1"/>
          <p:nvPr/>
        </p:nvSpPr>
        <p:spPr>
          <a:xfrm>
            <a:off x="7363117" y="3092652"/>
            <a:ext cx="738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IP</a:t>
            </a:r>
            <a:endParaRPr lang="en-CA" sz="14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EA3ABC-29C9-4D7D-A294-45902DB95EA2}"/>
              </a:ext>
            </a:extLst>
          </p:cNvPr>
          <p:cNvSpPr txBox="1"/>
          <p:nvPr/>
        </p:nvSpPr>
        <p:spPr>
          <a:xfrm>
            <a:off x="7896427" y="5586176"/>
            <a:ext cx="1188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8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784694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1</TotalTime>
  <Words>63</Words>
  <Application>Microsoft Office PowerPoint</Application>
  <PresentationFormat>Widescreen</PresentationFormat>
  <Paragraphs>31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gor Kovalchuk</dc:creator>
  <cp:lastModifiedBy>Igor Kovalchuk</cp:lastModifiedBy>
  <cp:revision>10</cp:revision>
  <dcterms:created xsi:type="dcterms:W3CDTF">2020-10-17T20:47:03Z</dcterms:created>
  <dcterms:modified xsi:type="dcterms:W3CDTF">2022-02-01T21:01:22Z</dcterms:modified>
</cp:coreProperties>
</file>